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notesMasterIdLst>
    <p:notesMasterId r:id="rId3"/>
  </p:notesMasterIdLst>
  <p:sldIdLst>
    <p:sldId id="272" r:id="rId2"/>
  </p:sldIdLst>
  <p:sldSz cx="9144000" cy="8280400"/>
  <p:notesSz cx="6797675" cy="9926638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96290" autoAdjust="0"/>
    <p:restoredTop sz="98476" autoAdjust="0"/>
  </p:normalViewPr>
  <p:slideViewPr>
    <p:cSldViewPr>
      <p:cViewPr varScale="1">
        <p:scale>
          <a:sx n="93" d="100"/>
          <a:sy n="93" d="100"/>
        </p:scale>
        <p:origin x="-2934" y="-102"/>
      </p:cViewPr>
      <p:guideLst>
        <p:guide orient="horz" pos="2608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S-P\Desktop\new%20p\supp\wb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S-P\Desktop\20.1.2015\New%20folder\new%20expt\in-vivo\&#1495;&#1494;&#1512;&#1492;%20&#1506;&#1500;%20&#1492;&#1504;&#1497;&#1505;&#1493;&#1497;%20&#1489;MVT%20&#1506;&#1501;%20&#1492;&#1493;&#1511;&#1496;&#1493;&#1512;%20&#1492;&#1513;&#1504;&#1497;\Book1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S-P\Desktop\20.1.2015\New%20folder\new%20expt\in-vivo\&#1495;&#1494;&#1512;&#1492;%20&#1506;&#1500;%20&#1492;&#1504;&#1497;&#1505;&#1493;&#1497;%20&#1489;MVT%20&#1506;&#1501;%20&#1492;&#1493;&#1511;&#1496;&#1493;&#1512;%20&#1492;&#1513;&#1504;&#1497;\Book1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918855251010728"/>
          <c:y val="5.1400554097404488E-2"/>
          <c:w val="0.7402558035066868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cat>
            <c:strRef>
              <c:f>Sheet1!$F$10:$G$10</c:f>
              <c:strCache>
                <c:ptCount val="2"/>
                <c:pt idx="0">
                  <c:v>control </c:v>
                </c:pt>
                <c:pt idx="1">
                  <c:v>IGF1R-KD</c:v>
                </c:pt>
              </c:strCache>
            </c:strRef>
          </c:cat>
          <c:val>
            <c:numRef>
              <c:f>Sheet1!$F$11:$G$11</c:f>
              <c:numCache>
                <c:formatCode>General</c:formatCode>
                <c:ptCount val="2"/>
                <c:pt idx="0">
                  <c:v>1</c:v>
                </c:pt>
                <c:pt idx="1">
                  <c:v>0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2522368"/>
        <c:axId val="72286592"/>
      </c:barChart>
      <c:catAx>
        <c:axId val="72522368"/>
        <c:scaling>
          <c:orientation val="minMax"/>
        </c:scaling>
        <c:delete val="0"/>
        <c:axPos val="b"/>
        <c:majorTickMark val="out"/>
        <c:minorTickMark val="none"/>
        <c:tickLblPos val="nextTo"/>
        <c:crossAx val="72286592"/>
        <c:crosses val="autoZero"/>
        <c:auto val="1"/>
        <c:lblAlgn val="ctr"/>
        <c:lblOffset val="100"/>
        <c:noMultiLvlLbl val="0"/>
      </c:catAx>
      <c:valAx>
        <c:axId val="722865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000" b="0" i="0" baseline="0" dirty="0">
                    <a:effectLst/>
                  </a:rPr>
                  <a:t>IGF1R/</a:t>
                </a:r>
                <a:r>
                  <a:rPr lang="en-US" sz="1000" b="0" i="0" baseline="0" dirty="0">
                    <a:effectLst/>
                    <a:latin typeface="Symbol" panose="05050102010706020507" pitchFamily="18" charset="2"/>
                  </a:rPr>
                  <a:t>b</a:t>
                </a:r>
                <a:r>
                  <a:rPr lang="en-US" sz="1000" b="0" i="0" baseline="0" dirty="0">
                    <a:effectLst/>
                  </a:rPr>
                  <a:t>-actin ratio</a:t>
                </a:r>
                <a:endParaRPr lang="he-IL" sz="1000" dirty="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25223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872009036845075"/>
          <c:y val="5.1400554097404488E-2"/>
          <c:w val="0.74414910794378553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O$62:$P$62</c:f>
                <c:numCache>
                  <c:formatCode>General</c:formatCode>
                  <c:ptCount val="2"/>
                  <c:pt idx="0">
                    <c:v>0.20300000000000001</c:v>
                  </c:pt>
                  <c:pt idx="1">
                    <c:v>8.4000000000000005E-2</c:v>
                  </c:pt>
                </c:numCache>
              </c:numRef>
            </c:plus>
            <c:minus>
              <c:numRef>
                <c:f>Sheet1!$O$62:$P$62</c:f>
                <c:numCache>
                  <c:formatCode>General</c:formatCode>
                  <c:ptCount val="2"/>
                  <c:pt idx="0">
                    <c:v>0.20300000000000001</c:v>
                  </c:pt>
                  <c:pt idx="1">
                    <c:v>8.4000000000000005E-2</c:v>
                  </c:pt>
                </c:numCache>
              </c:numRef>
            </c:minus>
          </c:errBars>
          <c:cat>
            <c:strRef>
              <c:f>Sheet1!$O$60:$P$60</c:f>
              <c:strCache>
                <c:ptCount val="2"/>
                <c:pt idx="0">
                  <c:v>CD24+ control </c:v>
                </c:pt>
                <c:pt idx="1">
                  <c:v>CD24+ IGF1R-KD</c:v>
                </c:pt>
              </c:strCache>
            </c:strRef>
          </c:cat>
          <c:val>
            <c:numRef>
              <c:f>Sheet1!$O$61:$P$61</c:f>
              <c:numCache>
                <c:formatCode>0.000</c:formatCode>
                <c:ptCount val="2"/>
                <c:pt idx="0">
                  <c:v>1.044</c:v>
                </c:pt>
                <c:pt idx="1">
                  <c:v>0.2909999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2327552"/>
        <c:axId val="72329088"/>
      </c:barChart>
      <c:catAx>
        <c:axId val="72327552"/>
        <c:scaling>
          <c:orientation val="minMax"/>
        </c:scaling>
        <c:delete val="0"/>
        <c:axPos val="b"/>
        <c:majorTickMark val="out"/>
        <c:minorTickMark val="none"/>
        <c:tickLblPos val="nextTo"/>
        <c:crossAx val="72329088"/>
        <c:crosses val="autoZero"/>
        <c:auto val="1"/>
        <c:lblAlgn val="ctr"/>
        <c:lblOffset val="100"/>
        <c:noMultiLvlLbl val="0"/>
      </c:catAx>
      <c:valAx>
        <c:axId val="723290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tumor weight, g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crossAx val="723275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126618547681539"/>
          <c:y val="0.15788203557888597"/>
          <c:w val="0.82502559055118119"/>
          <c:h val="0.67847623213764952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M$11</c:f>
              <c:strCache>
                <c:ptCount val="1"/>
                <c:pt idx="0">
                  <c:v>CD24+ control 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Q$12:$Q$1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19.440000000000001</c:v>
                  </c:pt>
                  <c:pt idx="4">
                    <c:v>73.3</c:v>
                  </c:pt>
                  <c:pt idx="5">
                    <c:v>94.31</c:v>
                  </c:pt>
                </c:numCache>
              </c:numRef>
            </c:plus>
            <c:minus>
              <c:numRef>
                <c:f>Sheet1!$Q$12:$Q$1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19.440000000000001</c:v>
                  </c:pt>
                  <c:pt idx="4">
                    <c:v>73.3</c:v>
                  </c:pt>
                  <c:pt idx="5">
                    <c:v>94.31</c:v>
                  </c:pt>
                </c:numCache>
              </c:numRef>
            </c:minus>
          </c:errBars>
          <c:xVal>
            <c:numRef>
              <c:f>Sheet1!$L$12:$L$17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Sheet1!$M$12:$M$17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3.74</c:v>
                </c:pt>
                <c:pt idx="4">
                  <c:v>347.56</c:v>
                </c:pt>
                <c:pt idx="5">
                  <c:v>637.3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N$11</c:f>
              <c:strCache>
                <c:ptCount val="1"/>
                <c:pt idx="0">
                  <c:v>CD24+ IGF1R-KD</c:v>
                </c:pt>
              </c:strCache>
            </c:strRef>
          </c:tx>
          <c:spPr>
            <a:ln>
              <a:solidFill>
                <a:schemeClr val="tx1"/>
              </a:solidFill>
              <a:prstDash val="lg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R$12:$R$1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10.73</c:v>
                  </c:pt>
                  <c:pt idx="4">
                    <c:v>44.94</c:v>
                  </c:pt>
                  <c:pt idx="5">
                    <c:v>45.66</c:v>
                  </c:pt>
                </c:numCache>
              </c:numRef>
            </c:plus>
            <c:minus>
              <c:numRef>
                <c:f>Sheet1!$R$12:$R$1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10.73</c:v>
                  </c:pt>
                  <c:pt idx="4">
                    <c:v>44.94</c:v>
                  </c:pt>
                  <c:pt idx="5">
                    <c:v>45.66</c:v>
                  </c:pt>
                </c:numCache>
              </c:numRef>
            </c:minus>
          </c:errBars>
          <c:xVal>
            <c:numRef>
              <c:f>Sheet1!$L$12:$L$17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Sheet1!$N$12:$N$17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1.71</c:v>
                </c:pt>
                <c:pt idx="4">
                  <c:v>88.52</c:v>
                </c:pt>
                <c:pt idx="5">
                  <c:v>136.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2346624"/>
        <c:axId val="74978432"/>
      </c:scatterChart>
      <c:valAx>
        <c:axId val="72346624"/>
        <c:scaling>
          <c:orientation val="minMax"/>
          <c:max val="6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time, week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4978432"/>
        <c:crosses val="autoZero"/>
        <c:crossBetween val="midCat"/>
        <c:majorUnit val="1"/>
      </c:valAx>
      <c:valAx>
        <c:axId val="749784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tumor volume,</a:t>
                </a:r>
                <a:r>
                  <a:rPr lang="en-US" b="0" baseline="0"/>
                  <a:t> mm</a:t>
                </a:r>
                <a:r>
                  <a:rPr lang="en-US" b="0" baseline="30000"/>
                  <a:t>3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2346624"/>
        <c:crosses val="autoZero"/>
        <c:crossBetween val="midCat"/>
      </c:valAx>
    </c:plotArea>
    <c:legend>
      <c:legendPos val="l"/>
      <c:layout>
        <c:manualLayout>
          <c:xMode val="edge"/>
          <c:yMode val="edge"/>
          <c:x val="0.38611111111111113"/>
          <c:y val="4.245771361913093E-3"/>
          <c:w val="0.60647244094488184"/>
          <c:h val="0.15817512394284047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52016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74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6BDB02D2-E5D9-42AB-8FE1-DDF452FB95A0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44613" y="744538"/>
            <a:ext cx="410845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52016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74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C10D1B7C-A58C-4B81-A66B-E80F874208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135316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10D1B7C-A58C-4B81-A66B-E80F87420854}" type="slidenum">
              <a:rPr lang="he-IL" smtClean="0"/>
              <a:t>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374766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72292"/>
            <a:ext cx="7772400" cy="177491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692227"/>
            <a:ext cx="6400800" cy="211610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16170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89371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331600"/>
            <a:ext cx="2057400" cy="70651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31600"/>
            <a:ext cx="6019800" cy="70651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969698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88170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320925"/>
            <a:ext cx="7772400" cy="1644579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509587"/>
            <a:ext cx="7772400" cy="18113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530339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932094"/>
            <a:ext cx="4038600" cy="546468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32094"/>
            <a:ext cx="4038600" cy="546468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09240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853507"/>
            <a:ext cx="4040188" cy="7724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625960"/>
            <a:ext cx="4040188" cy="477081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853507"/>
            <a:ext cx="4041775" cy="7724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625960"/>
            <a:ext cx="4041775" cy="477081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31499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661297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78404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329682"/>
            <a:ext cx="3008313" cy="140306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329683"/>
            <a:ext cx="5111750" cy="706709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732751"/>
            <a:ext cx="3008313" cy="566402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33010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5796280"/>
            <a:ext cx="5486400" cy="684284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739869"/>
            <a:ext cx="5486400" cy="49682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6480564"/>
            <a:ext cx="5486400" cy="97179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61786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331600"/>
            <a:ext cx="8229600" cy="1380067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932094"/>
            <a:ext cx="8229600" cy="5464681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7674704"/>
            <a:ext cx="2133600" cy="44085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43099E-6AE4-40B1-9DDC-EA8B27873DFB}" type="datetimeFigureOut">
              <a:rPr lang="he-IL" smtClean="0"/>
              <a:t>ל'/חש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7674704"/>
            <a:ext cx="2895600" cy="44085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7674704"/>
            <a:ext cx="2133600" cy="44085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AF52E6-7E87-494F-8AE9-B53A27FF8FC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25042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3" Type="http://schemas.openxmlformats.org/officeDocument/2006/relationships/image" Target="../media/image1.png"/><Relationship Id="rId7" Type="http://schemas.openxmlformats.org/officeDocument/2006/relationships/chart" Target="../charts/chart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chart" Target="../charts/char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205220" y="486330"/>
            <a:ext cx="3810119" cy="1208874"/>
            <a:chOff x="4067944" y="1465306"/>
            <a:chExt cx="3024872" cy="1208874"/>
          </a:xfrm>
        </p:grpSpPr>
        <p:pic>
          <p:nvPicPr>
            <p:cNvPr id="4" name="Picture 3"/>
            <p:cNvPicPr>
              <a:picLocks noChangeAspect="1" noChangeArrowheads="1"/>
            </p:cNvPicPr>
            <p:nvPr/>
          </p:nvPicPr>
          <p:blipFill rotWithShape="1">
            <a:blip r:embed="rId3"/>
            <a:srcRect t="16327" b="28163"/>
            <a:stretch/>
          </p:blipFill>
          <p:spPr bwMode="auto">
            <a:xfrm>
              <a:off x="5063998" y="2304066"/>
              <a:ext cx="1733550" cy="370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5" name="Picture 3"/>
            <p:cNvPicPr>
              <a:picLocks noChangeAspect="1" noChangeArrowheads="1"/>
            </p:cNvPicPr>
            <p:nvPr/>
          </p:nvPicPr>
          <p:blipFill rotWithShape="1">
            <a:blip r:embed="rId4"/>
            <a:srcRect l="4000" t="1" r="9143" b="4000"/>
            <a:stretch/>
          </p:blipFill>
          <p:spPr bwMode="auto">
            <a:xfrm>
              <a:off x="5093763" y="1795755"/>
              <a:ext cx="1654629" cy="3460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6" name="Group 5"/>
            <p:cNvGrpSpPr/>
            <p:nvPr/>
          </p:nvGrpSpPr>
          <p:grpSpPr>
            <a:xfrm>
              <a:off x="4067944" y="1465306"/>
              <a:ext cx="3024872" cy="1208874"/>
              <a:chOff x="-423186" y="1341438"/>
              <a:chExt cx="3024872" cy="1001215"/>
            </a:xfrm>
          </p:grpSpPr>
          <p:sp>
            <p:nvSpPr>
              <p:cNvPr id="7" name="TextBox 6"/>
              <p:cNvSpPr txBox="1">
                <a:spLocks noChangeArrowheads="1"/>
              </p:cNvSpPr>
              <p:nvPr/>
            </p:nvSpPr>
            <p:spPr bwMode="auto">
              <a:xfrm>
                <a:off x="218038" y="1341438"/>
                <a:ext cx="1439862" cy="2294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algn="ctr" eaLnBrk="1" hangingPunct="1"/>
                <a:r>
                  <a:rPr lang="en-US" altLang="he-IL" sz="1200" dirty="0" smtClean="0">
                    <a:latin typeface="Calibri" pitchFamily="34" charset="0"/>
                  </a:rPr>
                  <a:t>control</a:t>
                </a:r>
                <a:endParaRPr lang="he-IL" altLang="he-IL" sz="1200" dirty="0">
                  <a:latin typeface="Calibri" pitchFamily="34" charset="0"/>
                </a:endParaRPr>
              </a:p>
            </p:txBody>
          </p:sp>
          <p:sp>
            <p:nvSpPr>
              <p:cNvPr id="8" name="TextBox 7"/>
              <p:cNvSpPr txBox="1">
                <a:spLocks noChangeArrowheads="1"/>
              </p:cNvSpPr>
              <p:nvPr/>
            </p:nvSpPr>
            <p:spPr bwMode="auto">
              <a:xfrm>
                <a:off x="1161823" y="1343697"/>
                <a:ext cx="1439863" cy="2294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algn="ctr" eaLnBrk="1" hangingPunct="1"/>
                <a:r>
                  <a:rPr lang="en-US" altLang="he-IL" sz="1200" dirty="0" smtClean="0">
                    <a:latin typeface="Calibri" pitchFamily="34" charset="0"/>
                  </a:rPr>
                  <a:t>IGF1R-KD</a:t>
                </a:r>
                <a:endParaRPr lang="he-IL" altLang="he-IL" sz="1200" baseline="30000" dirty="0">
                  <a:latin typeface="Calibri" pitchFamily="34" charset="0"/>
                </a:endParaRPr>
              </a:p>
            </p:txBody>
          </p:sp>
          <p:sp>
            <p:nvSpPr>
              <p:cNvPr id="9" name="TextBox 8"/>
              <p:cNvSpPr txBox="1">
                <a:spLocks noChangeArrowheads="1"/>
              </p:cNvSpPr>
              <p:nvPr/>
            </p:nvSpPr>
            <p:spPr bwMode="auto">
              <a:xfrm>
                <a:off x="-423186" y="1643650"/>
                <a:ext cx="1008063" cy="2294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he-IL" sz="1200" dirty="0">
                    <a:latin typeface="Calibri" pitchFamily="34" charset="0"/>
                  </a:rPr>
                  <a:t>IGFIR</a:t>
                </a:r>
                <a:endParaRPr lang="he-IL" altLang="he-IL" sz="1200" dirty="0">
                  <a:latin typeface="Calibri" pitchFamily="34" charset="0"/>
                </a:endParaRPr>
              </a:p>
            </p:txBody>
          </p:sp>
          <p:sp>
            <p:nvSpPr>
              <p:cNvPr id="10" name="TextBox 10"/>
              <p:cNvSpPr txBox="1">
                <a:spLocks noChangeArrowheads="1"/>
              </p:cNvSpPr>
              <p:nvPr/>
            </p:nvSpPr>
            <p:spPr bwMode="auto">
              <a:xfrm>
                <a:off x="-405430" y="2113237"/>
                <a:ext cx="1008063" cy="2294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he-IL" sz="1200">
                    <a:latin typeface="Symbol" pitchFamily="18" charset="2"/>
                  </a:rPr>
                  <a:t>b</a:t>
                </a:r>
                <a:r>
                  <a:rPr lang="en-US" altLang="he-IL" sz="1200">
                    <a:latin typeface="Calibri" pitchFamily="34" charset="0"/>
                  </a:rPr>
                  <a:t>-actin</a:t>
                </a:r>
                <a:endParaRPr lang="he-IL" altLang="he-IL" sz="1200">
                  <a:latin typeface="Calibri" pitchFamily="34" charset="0"/>
                </a:endParaRPr>
              </a:p>
            </p:txBody>
          </p:sp>
        </p:grpSp>
      </p:grpSp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9555674"/>
              </p:ext>
            </p:extLst>
          </p:nvPr>
        </p:nvGraphicFramePr>
        <p:xfrm>
          <a:off x="323528" y="2246212"/>
          <a:ext cx="3835704" cy="24834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35" name="Group 34"/>
          <p:cNvGrpSpPr/>
          <p:nvPr/>
        </p:nvGrpSpPr>
        <p:grpSpPr>
          <a:xfrm>
            <a:off x="4245441" y="897200"/>
            <a:ext cx="4680520" cy="3542026"/>
            <a:chOff x="1596494" y="2795283"/>
            <a:chExt cx="4825942" cy="3464502"/>
          </a:xfrm>
        </p:grpSpPr>
        <p:sp>
          <p:nvSpPr>
            <p:cNvPr id="32" name="TextBox 31"/>
            <p:cNvSpPr txBox="1"/>
            <p:nvPr/>
          </p:nvSpPr>
          <p:spPr>
            <a:xfrm>
              <a:off x="2615202" y="5593744"/>
              <a:ext cx="2869373" cy="369332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dirty="0" smtClean="0"/>
                <a:t>CD24</a:t>
              </a:r>
              <a:endParaRPr lang="he-IL" dirty="0"/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48909" y="4342868"/>
              <a:ext cx="3464502" cy="369332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dirty="0" smtClean="0"/>
                <a:t>Count</a:t>
              </a:r>
              <a:endParaRPr lang="he-IL" dirty="0"/>
            </a:p>
          </p:txBody>
        </p:sp>
        <p:grpSp>
          <p:nvGrpSpPr>
            <p:cNvPr id="22" name="Group 21"/>
            <p:cNvGrpSpPr/>
            <p:nvPr/>
          </p:nvGrpSpPr>
          <p:grpSpPr>
            <a:xfrm>
              <a:off x="1979712" y="2873097"/>
              <a:ext cx="4442724" cy="2768385"/>
              <a:chOff x="1979712" y="2873097"/>
              <a:chExt cx="4442724" cy="2768385"/>
            </a:xfrm>
          </p:grpSpPr>
          <p:pic>
            <p:nvPicPr>
              <p:cNvPr id="1027" name="Picture 3" descr="Z:\RULA 2\rula\new.png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01" t="49919" r="70104" b="16343"/>
              <a:stretch/>
            </p:blipFill>
            <p:spPr bwMode="auto">
              <a:xfrm>
                <a:off x="4228313" y="3422528"/>
                <a:ext cx="2194123" cy="215783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2052506" y="3186274"/>
                <a:ext cx="2016224" cy="276999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200" dirty="0" smtClean="0"/>
                  <a:t>Control cells</a:t>
                </a:r>
                <a:endParaRPr lang="he-IL" sz="1200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317262" y="3175387"/>
                <a:ext cx="2016224" cy="276999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>
                <a:defPPr>
                  <a:defRPr lang="he-IL"/>
                </a:defPPr>
                <a:lvl1pPr algn="ctr">
                  <a:defRPr sz="1200"/>
                </a:lvl1pPr>
              </a:lstStyle>
              <a:p>
                <a:r>
                  <a:rPr lang="en-US" dirty="0" smtClean="0"/>
                  <a:t>IGF1RKD cells</a:t>
                </a:r>
                <a:endParaRPr lang="he-IL" dirty="0"/>
              </a:p>
            </p:txBody>
          </p:sp>
          <p:grpSp>
            <p:nvGrpSpPr>
              <p:cNvPr id="25" name="Group 51"/>
              <p:cNvGrpSpPr>
                <a:grpSpLocks/>
              </p:cNvGrpSpPr>
              <p:nvPr/>
            </p:nvGrpSpPr>
            <p:grpSpPr bwMode="auto">
              <a:xfrm>
                <a:off x="3059832" y="2873097"/>
                <a:ext cx="2183028" cy="400110"/>
                <a:chOff x="2260338" y="931595"/>
                <a:chExt cx="1523315" cy="252023"/>
              </a:xfrm>
            </p:grpSpPr>
            <p:cxnSp>
              <p:nvCxnSpPr>
                <p:cNvPr id="26" name="Straight Connector 25"/>
                <p:cNvCxnSpPr/>
                <p:nvPr/>
              </p:nvCxnSpPr>
              <p:spPr>
                <a:xfrm>
                  <a:off x="2260338" y="1017820"/>
                  <a:ext cx="288876" cy="1588"/>
                </a:xfrm>
                <a:prstGeom prst="line">
                  <a:avLst/>
                </a:prstGeom>
                <a:ln>
                  <a:solidFill>
                    <a:schemeClr val="accent5">
                      <a:lumMod val="60000"/>
                      <a:lumOff val="4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Connector 26"/>
                <p:cNvCxnSpPr/>
                <p:nvPr/>
              </p:nvCxnSpPr>
              <p:spPr>
                <a:xfrm>
                  <a:off x="3046261" y="1014639"/>
                  <a:ext cx="287288" cy="1588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TextBox 54"/>
                <p:cNvSpPr txBox="1">
                  <a:spLocks noChangeArrowheads="1"/>
                </p:cNvSpPr>
                <p:nvPr/>
              </p:nvSpPr>
              <p:spPr bwMode="auto">
                <a:xfrm>
                  <a:off x="3135582" y="935224"/>
                  <a:ext cx="648071" cy="1550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algn="r" rtl="1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algn="r" rtl="1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algn="r" rtl="1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algn="r" rtl="1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algn="r" rtl="1" eaLnBrk="1" fontAlgn="base" hangingPunct="1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000" dirty="0">
                      <a:solidFill>
                        <a:prstClr val="black"/>
                      </a:solidFill>
                    </a:rPr>
                    <a:t>stained</a:t>
                  </a:r>
                  <a:endParaRPr lang="he-IL" sz="1000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9" name="TextBox 55"/>
                <p:cNvSpPr txBox="1">
                  <a:spLocks noChangeArrowheads="1"/>
                </p:cNvSpPr>
                <p:nvPr/>
              </p:nvSpPr>
              <p:spPr bwMode="auto">
                <a:xfrm>
                  <a:off x="2422948" y="931595"/>
                  <a:ext cx="648070" cy="25202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algn="r" rtl="1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algn="r" rtl="1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algn="r" rtl="1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algn="r" rtl="1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algn="r" rtl="1" eaLnBrk="1" fontAlgn="base" hangingPunct="1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000" dirty="0">
                      <a:solidFill>
                        <a:prstClr val="black"/>
                      </a:solidFill>
                    </a:rPr>
                    <a:t>unstained</a:t>
                  </a:r>
                  <a:endParaRPr lang="he-IL" sz="1000" dirty="0">
                    <a:solidFill>
                      <a:prstClr val="black"/>
                    </a:solidFill>
                  </a:endParaRPr>
                </a:p>
              </p:txBody>
            </p:sp>
          </p:grpSp>
          <p:pic>
            <p:nvPicPr>
              <p:cNvPr id="30" name="Picture 3" descr="Z:\RULA 2\rula\new.png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87" r="71688" b="67086"/>
              <a:stretch/>
            </p:blipFill>
            <p:spPr bwMode="auto">
              <a:xfrm>
                <a:off x="2003342" y="3463273"/>
                <a:ext cx="2114551" cy="210514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31" name="Straight Arrow Connector 30"/>
              <p:cNvCxnSpPr/>
              <p:nvPr/>
            </p:nvCxnSpPr>
            <p:spPr>
              <a:xfrm>
                <a:off x="2320894" y="5641482"/>
                <a:ext cx="3744000" cy="0"/>
              </a:xfrm>
              <a:prstGeom prst="straightConnector1">
                <a:avLst/>
              </a:prstGeom>
              <a:ln w="2222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Arrow Connector 33"/>
              <p:cNvCxnSpPr/>
              <p:nvPr/>
            </p:nvCxnSpPr>
            <p:spPr>
              <a:xfrm flipV="1">
                <a:off x="1979712" y="3588410"/>
                <a:ext cx="0" cy="1653682"/>
              </a:xfrm>
              <a:prstGeom prst="straightConnector1">
                <a:avLst/>
              </a:prstGeom>
              <a:ln w="2222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8" name="Group 37"/>
          <p:cNvGrpSpPr/>
          <p:nvPr/>
        </p:nvGrpSpPr>
        <p:grpSpPr>
          <a:xfrm>
            <a:off x="5220072" y="5285432"/>
            <a:ext cx="3762375" cy="2743200"/>
            <a:chOff x="5004048" y="836712"/>
            <a:chExt cx="3762375" cy="2743200"/>
          </a:xfrm>
        </p:grpSpPr>
        <p:graphicFrame>
          <p:nvGraphicFramePr>
            <p:cNvPr id="39" name="Chart 3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0264053"/>
                </p:ext>
              </p:extLst>
            </p:nvPr>
          </p:nvGraphicFramePr>
          <p:xfrm>
            <a:off x="5004048" y="836712"/>
            <a:ext cx="376237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40" name="TextBox 39"/>
            <p:cNvSpPr txBox="1"/>
            <p:nvPr/>
          </p:nvSpPr>
          <p:spPr>
            <a:xfrm>
              <a:off x="6893034" y="2482483"/>
              <a:ext cx="1224136" cy="24622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000" dirty="0" smtClean="0"/>
                <a:t>***</a:t>
              </a:r>
              <a:endParaRPr lang="he-IL" sz="1000" dirty="0"/>
            </a:p>
          </p:txBody>
        </p:sp>
      </p:grpSp>
      <p:graphicFrame>
        <p:nvGraphicFramePr>
          <p:cNvPr id="41" name="Chart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5741494"/>
              </p:ext>
            </p:extLst>
          </p:nvPr>
        </p:nvGraphicFramePr>
        <p:xfrm>
          <a:off x="107504" y="5213424"/>
          <a:ext cx="439248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43" name="TextBox 42"/>
          <p:cNvSpPr txBox="1"/>
          <p:nvPr/>
        </p:nvSpPr>
        <p:spPr>
          <a:xfrm>
            <a:off x="622225" y="455551"/>
            <a:ext cx="435741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400" dirty="0" smtClean="0"/>
              <a:t>A</a:t>
            </a:r>
            <a:endParaRPr lang="he-IL" sz="1400" dirty="0"/>
          </a:p>
        </p:txBody>
      </p:sp>
      <p:sp>
        <p:nvSpPr>
          <p:cNvPr id="44" name="TextBox 43"/>
          <p:cNvSpPr txBox="1"/>
          <p:nvPr/>
        </p:nvSpPr>
        <p:spPr>
          <a:xfrm>
            <a:off x="600674" y="1990846"/>
            <a:ext cx="435741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400" dirty="0" smtClean="0"/>
              <a:t>B</a:t>
            </a:r>
            <a:endParaRPr lang="he-IL" sz="1400" dirty="0"/>
          </a:p>
        </p:txBody>
      </p:sp>
      <p:sp>
        <p:nvSpPr>
          <p:cNvPr id="45" name="TextBox 44"/>
          <p:cNvSpPr txBox="1"/>
          <p:nvPr/>
        </p:nvSpPr>
        <p:spPr>
          <a:xfrm>
            <a:off x="4518071" y="880095"/>
            <a:ext cx="435741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400" dirty="0" smtClean="0"/>
              <a:t>C</a:t>
            </a:r>
            <a:endParaRPr lang="he-IL" sz="1400" dirty="0"/>
          </a:p>
        </p:txBody>
      </p:sp>
      <p:sp>
        <p:nvSpPr>
          <p:cNvPr id="46" name="TextBox 45"/>
          <p:cNvSpPr txBox="1"/>
          <p:nvPr/>
        </p:nvSpPr>
        <p:spPr>
          <a:xfrm>
            <a:off x="107504" y="5056559"/>
            <a:ext cx="435741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400" dirty="0" smtClean="0"/>
              <a:t>D</a:t>
            </a:r>
            <a:endParaRPr lang="he-IL" sz="1400" dirty="0"/>
          </a:p>
        </p:txBody>
      </p:sp>
      <p:sp>
        <p:nvSpPr>
          <p:cNvPr id="47" name="TextBox 46"/>
          <p:cNvSpPr txBox="1"/>
          <p:nvPr/>
        </p:nvSpPr>
        <p:spPr>
          <a:xfrm>
            <a:off x="5240649" y="5065418"/>
            <a:ext cx="435741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400" dirty="0" smtClean="0"/>
              <a:t>E</a:t>
            </a:r>
            <a:endParaRPr lang="he-IL" sz="1400" dirty="0"/>
          </a:p>
        </p:txBody>
      </p:sp>
      <p:sp>
        <p:nvSpPr>
          <p:cNvPr id="37" name="TextBox 36"/>
          <p:cNvSpPr txBox="1"/>
          <p:nvPr/>
        </p:nvSpPr>
        <p:spPr>
          <a:xfrm>
            <a:off x="-2198352" y="8998"/>
            <a:ext cx="4139953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Supplementary S1</a:t>
            </a:r>
            <a:endParaRPr lang="he-IL" dirty="0"/>
          </a:p>
        </p:txBody>
      </p:sp>
      <p:sp>
        <p:nvSpPr>
          <p:cNvPr id="36" name="TextBox 35"/>
          <p:cNvSpPr txBox="1"/>
          <p:nvPr/>
        </p:nvSpPr>
        <p:spPr>
          <a:xfrm>
            <a:off x="2744225" y="5611897"/>
            <a:ext cx="1224136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 smtClean="0"/>
              <a:t>***</a:t>
            </a:r>
            <a:endParaRPr lang="he-IL" sz="1000" dirty="0"/>
          </a:p>
        </p:txBody>
      </p:sp>
      <p:sp>
        <p:nvSpPr>
          <p:cNvPr id="42" name="TextBox 41"/>
          <p:cNvSpPr txBox="1"/>
          <p:nvPr/>
        </p:nvSpPr>
        <p:spPr>
          <a:xfrm>
            <a:off x="2061994" y="6342251"/>
            <a:ext cx="1224136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 smtClean="0"/>
              <a:t>*</a:t>
            </a:r>
            <a:endParaRPr lang="he-IL" sz="1000" dirty="0"/>
          </a:p>
        </p:txBody>
      </p:sp>
      <p:sp>
        <p:nvSpPr>
          <p:cNvPr id="48" name="TextBox 47"/>
          <p:cNvSpPr txBox="1"/>
          <p:nvPr/>
        </p:nvSpPr>
        <p:spPr>
          <a:xfrm>
            <a:off x="1465382" y="7134249"/>
            <a:ext cx="1224136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 smtClean="0"/>
              <a:t>*</a:t>
            </a:r>
            <a:endParaRPr lang="he-IL" sz="1000" dirty="0"/>
          </a:p>
        </p:txBody>
      </p:sp>
    </p:spTree>
    <p:extLst>
      <p:ext uri="{BB962C8B-B14F-4D97-AF65-F5344CB8AC3E}">
        <p14:creationId xmlns:p14="http://schemas.microsoft.com/office/powerpoint/2010/main" val="11348250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24</TotalTime>
  <Words>37</Words>
  <Application>Microsoft Office PowerPoint</Application>
  <PresentationFormat>Custom</PresentationFormat>
  <Paragraphs>2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BS-P</dc:creator>
  <cp:lastModifiedBy>LABS-P</cp:lastModifiedBy>
  <cp:revision>132</cp:revision>
  <dcterms:created xsi:type="dcterms:W3CDTF">2015-04-20T12:33:36Z</dcterms:created>
  <dcterms:modified xsi:type="dcterms:W3CDTF">2015-11-12T11:33:43Z</dcterms:modified>
</cp:coreProperties>
</file>